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11.wmf" ContentType="image/x-wmf"/>
  <Override PartName="/ppt/media/image7.wmf" ContentType="image/x-wmf"/>
  <Override PartName="/ppt/media/image12.wmf" ContentType="image/x-wmf"/>
  <Override PartName="/ppt/media/image8.wmf" ContentType="image/x-wmf"/>
  <Override PartName="/ppt/media/image13.wmf" ContentType="image/x-wmf"/>
  <Override PartName="/ppt/media/image9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81800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B60BA5-ED36-4F3C-A8A2-1451C757C2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AF052F-5514-4396-BCEF-787B2F37D0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DB884C-E3CB-4711-B004-763A49BEAF9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B78E5B-0423-403C-8B73-A0F255F2F2E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A3A68A-A066-447D-92D2-7C732CD71D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23FF8B-A3D6-46CE-A720-6DC86EAE69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33968B-A296-4BAD-85A4-EC05D9B181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0B945A-7341-498E-B1E4-E4C5919F5F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BA0623-9ED2-4775-9447-91C58965BD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57D546-CD41-4358-B0A5-94F17E67CB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ABED8D-96B4-4652-B63B-16DBA886AC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B6A48E-1606-46A7-BB2E-7C4149BA15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2776147-1534-48B6-900E-BAA73F14453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image" Target="../media/image11.wmf"/><Relationship Id="rId12" Type="http://schemas.openxmlformats.org/officeDocument/2006/relationships/image" Target="../media/image12.wmf"/><Relationship Id="rId13" Type="http://schemas.openxmlformats.org/officeDocument/2006/relationships/image" Target="../media/image13.wmf"/><Relationship Id="rId14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1661" r="0" b="0"/>
          <a:stretch/>
        </p:blipFill>
        <p:spPr>
          <a:xfrm>
            <a:off x="4992840" y="2527200"/>
            <a:ext cx="1460520" cy="131616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0" t="0" r="0" b="4623"/>
          <a:stretch/>
        </p:blipFill>
        <p:spPr>
          <a:xfrm>
            <a:off x="4975200" y="1265400"/>
            <a:ext cx="1478160" cy="124272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2674800" y="2583000"/>
            <a:ext cx="1584360" cy="110628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4"/>
          <a:stretch/>
        </p:blipFill>
        <p:spPr>
          <a:xfrm>
            <a:off x="2637000" y="1476360"/>
            <a:ext cx="1590480" cy="107172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5"/>
          <a:stretch/>
        </p:blipFill>
        <p:spPr>
          <a:xfrm>
            <a:off x="595440" y="2084400"/>
            <a:ext cx="1393560" cy="120168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2629080" y="357984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962440" y="358308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299040" y="358308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632400" y="358308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971880" y="358308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602080" y="34909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488680" y="30132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485800" y="325764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5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485800" y="27655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45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488680" y="25239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6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599200" y="238284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542680" y="190512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588040" y="2149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539440" y="16606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542680" y="14130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862360" y="3780000"/>
            <a:ext cx="1224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175560" y="3743280"/>
            <a:ext cx="65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DP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V="1">
            <a:off x="2502000" y="1541520"/>
            <a:ext cx="0" cy="2109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rot="16200000">
            <a:off x="1933200" y="2504520"/>
            <a:ext cx="72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Times New Roman"/>
              </a:rPr>
              <a:t>Count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390120" y="2671920"/>
            <a:ext cx="82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Live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340440" y="1541520"/>
            <a:ext cx="87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Dead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09960" y="320760"/>
            <a:ext cx="1936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Additional file 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flipV="1">
            <a:off x="1557360" y="1979280"/>
            <a:ext cx="744480" cy="4366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844640" y="2948040"/>
            <a:ext cx="457200" cy="1094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4943520" y="374184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5261040" y="374328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5591160" y="374184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5940360" y="374184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6267600" y="374328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794480" y="366552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800600" y="337824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4797360" y="308628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4794480" y="279396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4794480" y="252252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4792680" y="236700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4799160" y="213372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4795920" y="183996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4792680" y="155088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4792680" y="125892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flipV="1">
            <a:off x="4803840" y="2685960"/>
            <a:ext cx="0" cy="1008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 flipV="1">
            <a:off x="4803840" y="1382760"/>
            <a:ext cx="0" cy="10857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5032440" y="3983040"/>
            <a:ext cx="12841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5445720" y="3965400"/>
            <a:ext cx="65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DP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rot="16200000">
            <a:off x="4137840" y="1854360"/>
            <a:ext cx="997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nnexin 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rot="16200000">
            <a:off x="4279320" y="3027600"/>
            <a:ext cx="71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7-AA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215280" y="1114560"/>
            <a:ext cx="450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A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230040" y="4211640"/>
            <a:ext cx="435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B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1174320" y="610704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1172520" y="587376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172520" y="564840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172520" y="541980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1172520" y="51847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1108800" y="495936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1108800" y="472932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1483560" y="62737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1940760" y="62737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2372760" y="62737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2818800" y="62737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3252240" y="62737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2196720" y="6478560"/>
            <a:ext cx="407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Hou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 rot="16200000">
            <a:off x="422280" y="5414040"/>
            <a:ext cx="867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Fold incre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7" name="" descr=""/>
          <p:cNvPicPr/>
          <p:nvPr/>
        </p:nvPicPr>
        <p:blipFill>
          <a:blip r:embed="rId6"/>
          <a:stretch/>
        </p:blipFill>
        <p:spPr>
          <a:xfrm>
            <a:off x="5084640" y="1332000"/>
            <a:ext cx="865440" cy="171360"/>
          </a:xfrm>
          <a:prstGeom prst="rect">
            <a:avLst/>
          </a:prstGeom>
          <a:ln w="0">
            <a:noFill/>
          </a:ln>
        </p:spPr>
      </p:pic>
      <p:pic>
        <p:nvPicPr>
          <p:cNvPr id="108" name="" descr=""/>
          <p:cNvPicPr/>
          <p:nvPr/>
        </p:nvPicPr>
        <p:blipFill>
          <a:blip r:embed="rId7"/>
          <a:stretch/>
        </p:blipFill>
        <p:spPr>
          <a:xfrm>
            <a:off x="5084640" y="2287440"/>
            <a:ext cx="865440" cy="169920"/>
          </a:xfrm>
          <a:prstGeom prst="rect">
            <a:avLst/>
          </a:prstGeom>
          <a:ln w="0">
            <a:noFill/>
          </a:ln>
        </p:spPr>
      </p:pic>
      <p:pic>
        <p:nvPicPr>
          <p:cNvPr id="109" name="" descr=""/>
          <p:cNvPicPr/>
          <p:nvPr/>
        </p:nvPicPr>
        <p:blipFill>
          <a:blip r:embed="rId8"/>
          <a:stretch/>
        </p:blipFill>
        <p:spPr>
          <a:xfrm>
            <a:off x="6021360" y="1311120"/>
            <a:ext cx="380880" cy="165240"/>
          </a:xfrm>
          <a:prstGeom prst="rect">
            <a:avLst/>
          </a:prstGeom>
          <a:ln w="0">
            <a:noFill/>
          </a:ln>
        </p:spPr>
      </p:pic>
      <p:pic>
        <p:nvPicPr>
          <p:cNvPr id="110" name="" descr=""/>
          <p:cNvPicPr/>
          <p:nvPr/>
        </p:nvPicPr>
        <p:blipFill>
          <a:blip r:embed="rId9"/>
          <a:stretch/>
        </p:blipFill>
        <p:spPr>
          <a:xfrm>
            <a:off x="6021360" y="2303640"/>
            <a:ext cx="380880" cy="163440"/>
          </a:xfrm>
          <a:prstGeom prst="rect">
            <a:avLst/>
          </a:prstGeom>
          <a:ln w="0">
            <a:noFill/>
          </a:ln>
        </p:spPr>
      </p:pic>
      <p:pic>
        <p:nvPicPr>
          <p:cNvPr id="111" name="" descr=""/>
          <p:cNvPicPr/>
          <p:nvPr/>
        </p:nvPicPr>
        <p:blipFill>
          <a:blip r:embed="rId10"/>
          <a:stretch/>
        </p:blipFill>
        <p:spPr>
          <a:xfrm>
            <a:off x="5100480" y="2556000"/>
            <a:ext cx="381240" cy="164880"/>
          </a:xfrm>
          <a:prstGeom prst="rect">
            <a:avLst/>
          </a:prstGeom>
          <a:ln w="0">
            <a:noFill/>
          </a:ln>
        </p:spPr>
      </p:pic>
      <p:pic>
        <p:nvPicPr>
          <p:cNvPr id="112" name="" descr=""/>
          <p:cNvPicPr/>
          <p:nvPr/>
        </p:nvPicPr>
        <p:blipFill>
          <a:blip r:embed="rId11"/>
          <a:stretch/>
        </p:blipFill>
        <p:spPr>
          <a:xfrm>
            <a:off x="5084640" y="3543480"/>
            <a:ext cx="444600" cy="164880"/>
          </a:xfrm>
          <a:prstGeom prst="rect">
            <a:avLst/>
          </a:prstGeom>
          <a:ln w="0">
            <a:noFill/>
          </a:ln>
        </p:spPr>
      </p:pic>
      <p:pic>
        <p:nvPicPr>
          <p:cNvPr id="113" name="" descr=""/>
          <p:cNvPicPr/>
          <p:nvPr/>
        </p:nvPicPr>
        <p:blipFill>
          <a:blip r:embed="rId12"/>
          <a:stretch/>
        </p:blipFill>
        <p:spPr>
          <a:xfrm>
            <a:off x="6021360" y="2556000"/>
            <a:ext cx="380880" cy="164880"/>
          </a:xfrm>
          <a:prstGeom prst="rect">
            <a:avLst/>
          </a:prstGeom>
          <a:ln w="0">
            <a:noFill/>
          </a:ln>
        </p:spPr>
      </p:pic>
      <p:pic>
        <p:nvPicPr>
          <p:cNvPr id="114" name="" descr=""/>
          <p:cNvPicPr/>
          <p:nvPr/>
        </p:nvPicPr>
        <p:blipFill>
          <a:blip r:embed="rId13"/>
          <a:stretch/>
        </p:blipFill>
        <p:spPr>
          <a:xfrm>
            <a:off x="6021360" y="3544920"/>
            <a:ext cx="380880" cy="163440"/>
          </a:xfrm>
          <a:prstGeom prst="rect">
            <a:avLst/>
          </a:prstGeom>
          <a:ln w="0">
            <a:noFill/>
          </a:ln>
        </p:spPr>
      </p:pic>
      <p:grpSp>
        <p:nvGrpSpPr>
          <p:cNvPr id="115" name=""/>
          <p:cNvGrpSpPr/>
          <p:nvPr/>
        </p:nvGrpSpPr>
        <p:grpSpPr>
          <a:xfrm>
            <a:off x="1276200" y="4799160"/>
            <a:ext cx="2232000" cy="1413720"/>
            <a:chOff x="1276200" y="4799160"/>
            <a:chExt cx="2232000" cy="1413720"/>
          </a:xfrm>
        </p:grpSpPr>
        <p:sp>
          <p:nvSpPr>
            <p:cNvPr id="116" name=""/>
            <p:cNvSpPr/>
            <p:nvPr/>
          </p:nvSpPr>
          <p:spPr>
            <a:xfrm>
              <a:off x="1300320" y="4799160"/>
              <a:ext cx="2207880" cy="138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1300320" y="5951520"/>
              <a:ext cx="2207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1300320" y="5719680"/>
              <a:ext cx="2207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1300320" y="5495040"/>
              <a:ext cx="2207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1300320" y="5262840"/>
              <a:ext cx="2207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1300320" y="5031000"/>
              <a:ext cx="2207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1300320" y="4799160"/>
              <a:ext cx="2207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1391040" y="6071040"/>
              <a:ext cx="127080" cy="1119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1832400" y="6101280"/>
              <a:ext cx="127080" cy="820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2274120" y="6026400"/>
              <a:ext cx="126720" cy="1569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2715840" y="5839200"/>
              <a:ext cx="127080" cy="3441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3157560" y="5585040"/>
              <a:ext cx="126720" cy="5983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1518120" y="6071040"/>
              <a:ext cx="126720" cy="1119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1959480" y="5921640"/>
              <a:ext cx="127080" cy="261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2401200" y="5592240"/>
              <a:ext cx="127080" cy="591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2842920" y="5338080"/>
              <a:ext cx="127080" cy="845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3284280" y="5046120"/>
              <a:ext cx="127080" cy="11372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1300320" y="4799160"/>
              <a:ext cx="0" cy="1384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1276200" y="6183360"/>
              <a:ext cx="24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1276200" y="5951520"/>
              <a:ext cx="24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1276200" y="5719680"/>
              <a:ext cx="24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1276200" y="5495040"/>
              <a:ext cx="24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276200" y="5262840"/>
              <a:ext cx="24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1276200" y="5031000"/>
              <a:ext cx="24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1276200" y="4799160"/>
              <a:ext cx="24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1300320" y="6183360"/>
              <a:ext cx="2207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 flipV="1">
              <a:off x="1300320" y="6183000"/>
              <a:ext cx="0" cy="29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flipV="1">
              <a:off x="1742040" y="6183000"/>
              <a:ext cx="0" cy="29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 flipV="1">
              <a:off x="2183400" y="6183000"/>
              <a:ext cx="0" cy="29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 flipV="1">
              <a:off x="2625120" y="6183000"/>
              <a:ext cx="0" cy="29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 flipV="1">
              <a:off x="3066840" y="6183000"/>
              <a:ext cx="0" cy="29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 flipV="1">
              <a:off x="3508200" y="6183000"/>
              <a:ext cx="0" cy="29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8" name=""/>
          <p:cNvGrpSpPr/>
          <p:nvPr/>
        </p:nvGrpSpPr>
        <p:grpSpPr>
          <a:xfrm>
            <a:off x="1411200" y="4835520"/>
            <a:ext cx="865080" cy="385560"/>
            <a:chOff x="1411200" y="4835520"/>
            <a:chExt cx="865080" cy="385560"/>
          </a:xfrm>
        </p:grpSpPr>
        <p:sp>
          <p:nvSpPr>
            <p:cNvPr id="149" name=""/>
            <p:cNvSpPr/>
            <p:nvPr/>
          </p:nvSpPr>
          <p:spPr>
            <a:xfrm>
              <a:off x="1411200" y="4857480"/>
              <a:ext cx="865080" cy="360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1484280" y="4930560"/>
              <a:ext cx="71280" cy="709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120" bIns="24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1513440" y="4835520"/>
              <a:ext cx="51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PDP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1484280" y="5070240"/>
              <a:ext cx="71280" cy="70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120" bIns="24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1513080" y="4974840"/>
              <a:ext cx="76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Annexin 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4" name=""/>
          <p:cNvSpPr/>
          <p:nvPr/>
        </p:nvSpPr>
        <p:spPr>
          <a:xfrm>
            <a:off x="938160" y="3367080"/>
            <a:ext cx="873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812520" y="3348000"/>
            <a:ext cx="1081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Times New Roman"/>
              </a:rPr>
              <a:t>Forward Scatt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 flipV="1">
            <a:off x="549360" y="2244240"/>
            <a:ext cx="0" cy="792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 rot="16200000">
            <a:off x="-207000" y="2536920"/>
            <a:ext cx="111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Times New Roman"/>
              </a:rPr>
              <a:t>Sideward Scatt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10T17:49:36Z</dcterms:created>
  <dc:creator>Stefan Poehlmann</dc:creator>
  <dc:description/>
  <dc:language>en-US</dc:language>
  <cp:lastModifiedBy>Stefan Poehlmann</cp:lastModifiedBy>
  <dcterms:modified xsi:type="dcterms:W3CDTF">2010-03-31T17:29:29Z</dcterms:modified>
  <cp:revision>6</cp:revision>
  <dc:subject/>
  <dc:title>Folie 1</dc:title>
</cp:coreProperties>
</file>